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BAC3E8-ABF7-4D80-B0F5-EA6754CEAC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7C6A9-B9A5-4B62-956A-9C44BEAB05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1B988C-BA22-4C37-BE63-7B76345A68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D2DF9-D218-4A1C-AD1A-116CA4F56E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CB37A4-4C21-47EB-94AC-DFCB0D7C2A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009AF-1D5D-472B-B56B-2D569A2BDD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13257-62B2-4333-9211-488C0C32D8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8FC325-FDC8-4A8F-9C3E-09F7648EBB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DAFE81-5153-4921-8EAE-F52F06D72E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927A9-A8BB-4EE1-8F23-2D34014661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7C93C-C8BF-4818-A970-87F2091394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02072D-2C63-4DD8-9BF7-928D544C58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AC68E6-66D1-4362-9D33-864BA0F3C924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3" descr="C:\Users\HP2\AppData\Local\Temp\Rar$DI02.801\nsp1-7 10.tif"/>
          <p:cNvPicPr/>
          <p:nvPr/>
        </p:nvPicPr>
        <p:blipFill>
          <a:blip r:embed="rId1"/>
          <a:stretch/>
        </p:blipFill>
        <p:spPr>
          <a:xfrm>
            <a:off x="1403280" y="907920"/>
            <a:ext cx="6193080" cy="4249800"/>
          </a:xfrm>
          <a:prstGeom prst="rect">
            <a:avLst/>
          </a:prstGeom>
          <a:ln w="0">
            <a:noFill/>
          </a:ln>
        </p:spPr>
      </p:pic>
      <p:sp>
        <p:nvSpPr>
          <p:cNvPr id="42" name="テキスト ボックス 4"/>
          <p:cNvSpPr/>
          <p:nvPr/>
        </p:nvSpPr>
        <p:spPr>
          <a:xfrm>
            <a:off x="1258920" y="5445000"/>
            <a:ext cx="6913440" cy="1006560"/>
          </a:xfrm>
          <a:prstGeom prst="rect">
            <a:avLst/>
          </a:prstGeom>
          <a:noFill/>
          <a:ln w="93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lectropherotypes of representative rotavirus strains analyzed in this study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aving distinct migration patterns of NSP1 gene (RNA segment 5). Strains names in each lane are as follows:1, Y106; 2, L210; 3, L1450; 4, L1621; 5, 723; 6,  31; 7, 1861; 8,  956; 9, R1267; 10, L148; 11, L478; 12, E093; 13, E717; 14, E2422; 15, Z1557; 16, E1857. Strains in lanes 1-11 have NSP1 gene (segment 5) with migration pattern E-A1-1(with asterisk), while strains in lanes 12-15 with migration pattern E-A1-2 (with arrow).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テキスト ボックス 1"/>
          <p:cNvSpPr/>
          <p:nvPr/>
        </p:nvSpPr>
        <p:spPr>
          <a:xfrm>
            <a:off x="1258920" y="2637000"/>
            <a:ext cx="217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4" name="直線矢印コネクタ 8"/>
          <p:cNvCxnSpPr/>
          <p:nvPr/>
        </p:nvCxnSpPr>
        <p:spPr>
          <a:xfrm flipH="1">
            <a:off x="7524360" y="2852280"/>
            <a:ext cx="21672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27T08:24:42Z</dcterms:created>
  <dc:creator>HP2</dc:creator>
  <dc:description/>
  <dc:language>en-US</dc:language>
  <cp:lastModifiedBy>user</cp:lastModifiedBy>
  <cp:lastPrinted>2013-10-22T10:16:49Z</cp:lastPrinted>
  <dcterms:modified xsi:type="dcterms:W3CDTF">2013-10-28T02:27:24Z</dcterms:modified>
  <cp:revision>9</cp:revision>
  <dc:subject/>
  <dc:title>PowerPoint プレゼンテーション</dc:title>
</cp:coreProperties>
</file>